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12193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308D1A-6CEB-4F16-9230-4E14B402E6E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7B429A-A58B-40F9-80B6-2F3699D3FBF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6FBC4D-A369-42AE-BEB2-4844EDBD26B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AF602D-5A7B-4951-8B76-7AC48F7D5B1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29F746-608E-4A17-8A23-93C655C9674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E75D74-6494-4E27-BC2B-3D1DA7B9D9C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5E0CF9-449D-434A-9976-0EBB8515D67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1F475D-7832-4B49-979E-D8013C4DFB1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247D31-06C8-4579-9E46-5875FA8D7D2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D521DC-2392-4055-BEEB-48FB719EBF4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E8D341-11B9-43F8-8A11-EA2FB152258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D54E3E-87E9-45BA-97FA-693C3922744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863BFD3-750B-467F-B050-15D2157ABEE2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1" descr="G:\HGVO+Ak6U\harvesting day\20141204_143729.jpg"/>
          <p:cNvPicPr/>
          <p:nvPr/>
        </p:nvPicPr>
        <p:blipFill>
          <a:blip r:embed="rId1"/>
          <a:srcRect l="8314" t="0" r="18660" b="0"/>
          <a:stretch/>
        </p:blipFill>
        <p:spPr>
          <a:xfrm>
            <a:off x="3164040" y="1536840"/>
            <a:ext cx="4008240" cy="411768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2" descr="G:\HGVO+Ak6U\harvesting day\20141204_142701.jpg"/>
          <p:cNvPicPr/>
          <p:nvPr/>
        </p:nvPicPr>
        <p:blipFill>
          <a:blip r:embed="rId2"/>
          <a:srcRect l="28073" t="6572" r="47485" b="16343"/>
          <a:stretch/>
        </p:blipFill>
        <p:spPr>
          <a:xfrm>
            <a:off x="7148520" y="1536840"/>
            <a:ext cx="2098800" cy="4117680"/>
          </a:xfrm>
          <a:prstGeom prst="rect">
            <a:avLst/>
          </a:prstGeom>
          <a:ln w="0">
            <a:noFill/>
          </a:ln>
        </p:spPr>
      </p:pic>
      <p:sp>
        <p:nvSpPr>
          <p:cNvPr id="43" name="TextBox 5"/>
          <p:cNvSpPr/>
          <p:nvPr/>
        </p:nvSpPr>
        <p:spPr>
          <a:xfrm>
            <a:off x="7597080" y="4626000"/>
            <a:ext cx="1024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Biomass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TextBox 6"/>
          <p:cNvSpPr/>
          <p:nvPr/>
        </p:nvSpPr>
        <p:spPr>
          <a:xfrm>
            <a:off x="3821040" y="3257640"/>
            <a:ext cx="7765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ffffff"/>
                </a:solidFill>
                <a:latin typeface="Arial"/>
                <a:ea typeface="Arial"/>
              </a:rPr>
              <a:t>HVGO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TextBox 7"/>
          <p:cNvSpPr/>
          <p:nvPr/>
        </p:nvSpPr>
        <p:spPr>
          <a:xfrm>
            <a:off x="4307040" y="4456080"/>
            <a:ext cx="17215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Culture medium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TextBox 9"/>
          <p:cNvSpPr/>
          <p:nvPr/>
        </p:nvSpPr>
        <p:spPr>
          <a:xfrm>
            <a:off x="3115440" y="996840"/>
            <a:ext cx="23965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Abiotic control culture 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TextBox 10"/>
          <p:cNvSpPr/>
          <p:nvPr/>
        </p:nvSpPr>
        <p:spPr>
          <a:xfrm>
            <a:off x="6031440" y="988920"/>
            <a:ext cx="3027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Biological treatment cultures 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Rounded Rectangle 10"/>
          <p:cNvSpPr/>
          <p:nvPr/>
        </p:nvSpPr>
        <p:spPr>
          <a:xfrm>
            <a:off x="2781360" y="708120"/>
            <a:ext cx="7007040" cy="5410080"/>
          </a:xfrm>
          <a:prstGeom prst="roundRect">
            <a:avLst>
              <a:gd name="adj" fmla="val 16667"/>
            </a:avLst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TextBox 1"/>
          <p:cNvSpPr/>
          <p:nvPr/>
        </p:nvSpPr>
        <p:spPr>
          <a:xfrm>
            <a:off x="1140120" y="1158840"/>
            <a:ext cx="1223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Figure S2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TextBox 5"/>
          <p:cNvSpPr/>
          <p:nvPr/>
        </p:nvSpPr>
        <p:spPr>
          <a:xfrm>
            <a:off x="5998680" y="4417920"/>
            <a:ext cx="1024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Biomass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7-01-28T17:30:13Z</dcterms:created>
  <dc:creator>Wael Ahmed Ismail Elmoslimany</dc:creator>
  <dc:description/>
  <dc:language>en-US</dc:language>
  <cp:lastModifiedBy>Wael Ahmed Ismail Elmoslimany</cp:lastModifiedBy>
  <dcterms:modified xsi:type="dcterms:W3CDTF">2017-04-12T09:48:53Z</dcterms:modified>
  <cp:revision>12</cp:revision>
  <dc:subject/>
  <dc:title>PowerPoint Presentation</dc:title>
</cp:coreProperties>
</file>